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  <p:sldMasterId id="2147483672" r:id="rId3"/>
    <p:sldMasterId id="2147483684" r:id="rId4"/>
  </p:sldMasterIdLst>
  <p:notesMasterIdLst>
    <p:notesMasterId r:id="rId19"/>
  </p:notesMasterIdLst>
  <p:sldIdLst>
    <p:sldId id="273" r:id="rId5"/>
    <p:sldId id="281" r:id="rId6"/>
    <p:sldId id="271" r:id="rId7"/>
    <p:sldId id="269" r:id="rId8"/>
    <p:sldId id="274" r:id="rId9"/>
    <p:sldId id="286" r:id="rId10"/>
    <p:sldId id="275" r:id="rId11"/>
    <p:sldId id="270" r:id="rId12"/>
    <p:sldId id="257" r:id="rId13"/>
    <p:sldId id="284" r:id="rId14"/>
    <p:sldId id="285" r:id="rId15"/>
    <p:sldId id="287" r:id="rId16"/>
    <p:sldId id="263" r:id="rId17"/>
    <p:sldId id="278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21" d="100"/>
          <a:sy n="121" d="100"/>
        </p:scale>
        <p:origin x="744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2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AB260-A3E6-4C2E-A990-0AD33F11B25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910170-0511-421F-B858-471F2B2C3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165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910170-0511-421F-B858-471F2B2C309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9160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ost-seizure Lactat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910170-0511-421F-B858-471F2B2C309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5744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ost-seizure VBG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910170-0511-421F-B858-471F2B2C3098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1329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urtesy of </a:t>
            </a:r>
            <a:r>
              <a:rPr lang="en-US" dirty="0" err="1"/>
              <a:t>Yaïr</a:t>
            </a:r>
            <a:r>
              <a:rPr lang="en-US" dirty="0"/>
              <a:t> Glick, Radiopaedia.org, </a:t>
            </a:r>
            <a:r>
              <a:rPr lang="en-US" dirty="0" err="1"/>
              <a:t>rID</a:t>
            </a:r>
            <a:r>
              <a:rPr lang="en-US" dirty="0"/>
              <a:t>: 17806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910170-0511-421F-B858-471F2B2C3098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81492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ourtesy of Bruno Di </a:t>
            </a:r>
            <a:r>
              <a:rPr lang="en-US" dirty="0" err="1"/>
              <a:t>Muzio</a:t>
            </a:r>
            <a:r>
              <a:rPr lang="en-US" dirty="0"/>
              <a:t>, Radiopaedia.org, </a:t>
            </a:r>
            <a:r>
              <a:rPr lang="en-US" dirty="0" err="1"/>
              <a:t>rID</a:t>
            </a:r>
            <a:r>
              <a:rPr lang="en-US" dirty="0"/>
              <a:t>: 3777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910170-0511-421F-B858-471F2B2C3098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1405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2715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7241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501944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08646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75741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27813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30597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5694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6184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65478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234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846441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92992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4761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23629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9D504-0873-4C54-BC8D-426B56C1BC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C73569-8E14-46F9-9FC6-98838BA838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4C8770-128F-4DC4-BBD8-CA91D333C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9AF22A-AEA5-4F3E-B3CA-28A1BCD7F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5FAF4-38F1-48D6-B0D3-471B1EF6B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24632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77BA9-A9FD-4538-8919-21753BC83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BB4059-D031-460C-B422-3BE9621193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84FC91-5B4F-4E7F-9DE2-B716514AD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F28859-6FD3-4B1A-9945-9F87E706C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8782E-9141-40E9-9968-4AC33C1C9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21778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E40369-B0D5-4983-A560-A21D958D7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2B957-EF60-4558-83F0-3738639124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C4A2E0-78A0-4205-8984-259539CD6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BBA724-0307-49EB-BB0B-DF414A61A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8AAB4E-ADEC-4D92-9AF1-248E894E1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640425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D581C6-EF69-449B-80EA-C959C32F91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A6B3E5-801C-49A9-B4CE-8B2E7AA24A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D11A3F-3899-421F-9B86-CF9F8ABC9E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55E0DA-E3D6-4597-976B-41500C445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9A73F1-95B6-4636-92C8-808B54C04C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786794-DBA8-40ED-BD70-8C894F8D1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556973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42A5A8-80BF-4F02-8F84-7733AB161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71B117-EC90-429C-81B3-E45EF1E684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81F1D5-1972-479D-9B60-9C8552DA14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0A301D9-F19E-4D6E-BD6D-01CE6D123C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C7031E-A57B-4BF2-9FEF-15B50052CD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E21D81-3C2D-45C2-BD1C-BCAF00A5B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8731A7-3A10-4BBD-8E2B-49E7CD969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F2C1A8-DE9D-4353-9F5D-99F3BC766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074670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604EDD-E593-49E5-97B6-D1C9C9B49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AF5308-CDBE-465B-BF3E-F9B3FB559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E146C9-89A2-4B8B-94C5-55164050B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BB2998-A698-41FF-B8ED-AB64B65F7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73783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6A97B1-1887-4249-90E8-2F63A8F9B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999B7B-0C86-4C33-BD78-9EFCDDC94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8640FF-ACB1-48F0-B488-6D1ECB51DF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73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26544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AE8F0-14B7-4494-A3DE-BDD7D767B2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211871-28D5-49FC-B063-2EAE36BC5D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5D0303-D868-4CA8-B8B3-2E1B9647C0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F73F4C-0392-4694-ACC5-87870EDC5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0F1500-62CD-483E-82E2-0F39CD509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056757-87BE-4245-B989-3EFCFEDDB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568977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589EE3-20D0-4535-9E68-1F74E5426D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3C1162-1B3D-452F-B17B-8A7684CEFB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3D9CDD-2EDD-4AC9-ACF3-98C07FC82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DBE00E-253E-4042-B95B-243550CE6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75110E-CED0-46D8-9951-39D300201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CB31CD-C0D5-4B40-80E8-D951A3A27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651490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A04A9-0467-4FE4-850B-AA1E9959DD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B36D31-D643-474B-8808-AF31684BAC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13C031-C426-40E0-AC6B-17FADA09D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0C4638-FBBE-4134-B78A-CD8001A34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D2CC6F-016C-4225-8B11-B17CAA73D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97989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007F59-1515-44AF-9ABA-E60373A480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88A82F-DB28-4C49-B252-9531F29B44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BC938E-60BF-424E-817C-B5FB75702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A421A3-99D7-472C-A5D0-1864D1542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65F727-01AE-40AB-94E3-5D69E9526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759942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530653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237857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757860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301199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18838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49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755072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25542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844833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765666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684096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461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8711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6655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2143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0970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8207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4716A8-4486-4082-A559-F3E9C5B31FD1}" type="datetimeFigureOut">
              <a:rPr lang="en-US" smtClean="0"/>
              <a:t>6/17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0A98-1705-46E0-AEF7-6E191299E63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1148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C7568-5617-47ED-BD47-07E1CA7BDAAA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91E6A2-30BB-47EF-A80F-047A1D5134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566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FAF8CF-BF78-49C5-B70E-08801EAB0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786730-ED10-4130-87D6-6554450058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AB50CB-6EB2-4CA6-93D1-4DDD05C25D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CEC3F3-7BAB-4A7F-A1A0-F39B872F212D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0D0018-A38A-4597-95AE-2368B694C3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76EB03-D05C-4187-9D48-BC9BDC3680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B7CD63-B991-4A84-959A-573720BAC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36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7588D-8202-3042-AFFE-036E11ADB753}" type="datetimeFigureOut">
              <a:rPr lang="en-US" smtClean="0"/>
              <a:t>6/17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5E091-4D6C-6F4A-B94E-D1FC0369C7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310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A349A8A-4EC4-A472-D517-41BEA3C00C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7750" y="2274838"/>
            <a:ext cx="10096500" cy="2308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3600" b="1" dirty="0"/>
              <a:t>Subarachnoid Hemorrhage Causing a Seizure:</a:t>
            </a:r>
          </a:p>
          <a:p>
            <a:pPr algn="ctr"/>
            <a:r>
              <a:rPr lang="en-US" sz="3600" b="1" dirty="0"/>
              <a:t>An Assessment Simulation for Medical Students</a:t>
            </a:r>
          </a:p>
          <a:p>
            <a:pPr algn="ctr"/>
            <a:endParaRPr lang="en-US" sz="3600" b="1" dirty="0"/>
          </a:p>
          <a:p>
            <a:pPr algn="ctr"/>
            <a:r>
              <a:rPr lang="en-US" sz="3600" b="1" dirty="0"/>
              <a:t>Simulation Scenario Stimuli</a:t>
            </a:r>
          </a:p>
        </p:txBody>
      </p:sp>
    </p:spTree>
    <p:extLst>
      <p:ext uri="{BB962C8B-B14F-4D97-AF65-F5344CB8AC3E}">
        <p14:creationId xmlns:p14="http://schemas.microsoft.com/office/powerpoint/2010/main" val="15168303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Box 1"/>
          <p:cNvSpPr txBox="1">
            <a:spLocks noChangeArrowheads="1"/>
          </p:cNvSpPr>
          <p:nvPr/>
        </p:nvSpPr>
        <p:spPr bwMode="auto">
          <a:xfrm>
            <a:off x="4800600" y="1555957"/>
            <a:ext cx="7107176" cy="4801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Color								Yellow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Specific Gravity					1.02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pH									7.0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Blood								Negativ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Protein								Negativ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Glucose							Negativ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3400" dirty="0">
                <a:latin typeface="Calibri"/>
              </a:rPr>
              <a:t>Ketones							Negative</a:t>
            </a:r>
            <a:endParaRPr kumimoji="0" lang="en-US" sz="3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Leukocyte Esterase			Negativ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/>
                <a:ea typeface="+mn-ea"/>
                <a:cs typeface="+mn-cs"/>
              </a:rPr>
              <a:t>Nitrates							Negativ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B0EDA25-AA5A-443B-94E3-A8331FED6A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801" y="1677970"/>
            <a:ext cx="3809223" cy="4312763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id="{1E2A6E7B-72CA-44B6-AD72-D976E8EC85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5800" y="177814"/>
            <a:ext cx="115062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7200" b="1" dirty="0"/>
              <a:t>Urinalysis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1056457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Box 1"/>
          <p:cNvSpPr txBox="1">
            <a:spLocks noChangeArrowheads="1"/>
          </p:cNvSpPr>
          <p:nvPr/>
        </p:nvSpPr>
        <p:spPr bwMode="auto">
          <a:xfrm>
            <a:off x="4536676" y="1743416"/>
            <a:ext cx="7640576" cy="42473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700" dirty="0"/>
              <a:t>Amphetamine/Methamphetamine	Negative</a:t>
            </a:r>
          </a:p>
          <a:p>
            <a:r>
              <a:rPr lang="en-US" sz="2700" dirty="0"/>
              <a:t>Barbiturates					Negative</a:t>
            </a:r>
          </a:p>
          <a:p>
            <a:r>
              <a:rPr lang="en-US" sz="2700" dirty="0"/>
              <a:t>Benzodiazepines				Negative</a:t>
            </a:r>
          </a:p>
          <a:p>
            <a:r>
              <a:rPr lang="en-US" sz="2700" dirty="0"/>
              <a:t>Buprenorphine				Negative</a:t>
            </a:r>
          </a:p>
          <a:p>
            <a:r>
              <a:rPr lang="en-US" sz="2700" dirty="0"/>
              <a:t>Cannabinoids (Marijuana)			Negative</a:t>
            </a:r>
          </a:p>
          <a:p>
            <a:r>
              <a:rPr lang="en-US" sz="2700" dirty="0"/>
              <a:t>Cocaine					Negative</a:t>
            </a:r>
          </a:p>
          <a:p>
            <a:r>
              <a:rPr lang="en-US" sz="2700" dirty="0"/>
              <a:t>Fentanyl					Negative</a:t>
            </a:r>
          </a:p>
          <a:p>
            <a:r>
              <a:rPr lang="en-US" sz="2700" dirty="0"/>
              <a:t>Methadone					Negative</a:t>
            </a:r>
          </a:p>
          <a:p>
            <a:r>
              <a:rPr lang="en-US" sz="2700" dirty="0"/>
              <a:t>Opiates					Negative</a:t>
            </a:r>
          </a:p>
          <a:p>
            <a:r>
              <a:rPr lang="en-US" sz="2700" dirty="0"/>
              <a:t>Oxycodone					Negativ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B0EDA25-AA5A-443B-94E3-A8331FED6A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801" y="1677970"/>
            <a:ext cx="3809223" cy="4312763"/>
          </a:xfrm>
          <a:prstGeom prst="rect">
            <a:avLst/>
          </a:prstGeom>
        </p:spPr>
      </p:pic>
      <p:sp>
        <p:nvSpPr>
          <p:cNvPr id="6" name="TextBox 1">
            <a:extLst>
              <a:ext uri="{FF2B5EF4-FFF2-40B4-BE49-F238E27FC236}">
                <a16:creationId xmlns:a16="http://schemas.microsoft.com/office/drawing/2014/main" id="{1E2A6E7B-72CA-44B6-AD72-D976E8EC85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600" y="177814"/>
            <a:ext cx="115824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7200" b="1" dirty="0"/>
              <a:t>Urine Drug Screen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10164258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533400" y="228600"/>
            <a:ext cx="2495238" cy="1371600"/>
          </a:xfrm>
        </p:spPr>
        <p:txBody>
          <a:bodyPr>
            <a:normAutofit/>
          </a:bodyPr>
          <a:lstStyle/>
          <a:p>
            <a:r>
              <a:rPr lang="en-US" sz="7000" b="1" dirty="0"/>
              <a:t>VBG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0AF17D5-16D1-498E-A3AB-B3955A6716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6D3087F-373D-5DB7-3153-2AB7F9BE03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57800" y="1600200"/>
            <a:ext cx="6477000" cy="37856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! pH: 			7.14 !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! paCO</a:t>
            </a:r>
            <a:r>
              <a:rPr kumimoji="0" lang="en-US" sz="6000" b="0" i="0" u="none" strike="noStrike" kern="1200" cap="none" spc="0" normalizeH="0" baseline="-2500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</a:t>
            </a: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		55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mHg</a:t>
            </a: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!</a:t>
            </a:r>
            <a:endParaRPr kumimoji="0" lang="en-US" sz="30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O</a:t>
            </a:r>
            <a:r>
              <a:rPr kumimoji="0" lang="en-US" sz="6000" b="0" i="0" u="none" strike="noStrike" kern="1200" cap="none" spc="0" normalizeH="0" baseline="-2500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</a:t>
            </a: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			63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mHg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! HCO</a:t>
            </a:r>
            <a:r>
              <a:rPr kumimoji="0" lang="en-US" sz="6000" b="0" i="0" u="none" strike="noStrike" kern="1200" cap="none" spc="0" normalizeH="0" baseline="-2500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</a:t>
            </a: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		14 </a:t>
            </a:r>
            <a:r>
              <a:rPr kumimoji="0" lang="en-US" sz="35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  <a:r>
              <a:rPr kumimoji="0" lang="en-US" sz="60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! </a:t>
            </a:r>
            <a:endParaRPr kumimoji="0" lang="en-US" sz="35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361532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152400"/>
            <a:ext cx="10972800" cy="1143000"/>
          </a:xfrm>
        </p:spPr>
        <p:txBody>
          <a:bodyPr/>
          <a:lstStyle/>
          <a:p>
            <a:r>
              <a:rPr lang="en-US" b="1" dirty="0"/>
              <a:t>CT Head Without Contrast</a:t>
            </a:r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5E7691C1-929F-4E2B-82F2-9EC639C8C2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77000" y="2209800"/>
            <a:ext cx="4953000" cy="3124200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CT IMPRESSION: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No acute intracranial hemorrhage, edema pattern or mass effect.</a:t>
            </a:r>
          </a:p>
          <a:p>
            <a:endParaRPr lang="en-US" dirty="0"/>
          </a:p>
        </p:txBody>
      </p:sp>
      <p:pic>
        <p:nvPicPr>
          <p:cNvPr id="5" name="Picture 4" descr="A close-up of a brain scan&#10;&#10;Description automatically generated">
            <a:extLst>
              <a:ext uri="{FF2B5EF4-FFF2-40B4-BE49-F238E27FC236}">
                <a16:creationId xmlns:a16="http://schemas.microsoft.com/office/drawing/2014/main" id="{2ADE7409-EE9C-3429-E4D2-ACCBBE247C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1524000"/>
            <a:ext cx="3487680" cy="4692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2639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T Angiography Head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F2F5A348-49AB-4473-B0DB-08107F1DA8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553200" y="2438570"/>
            <a:ext cx="5181600" cy="312420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CT IMPRESSION:</a:t>
            </a:r>
            <a:br>
              <a:rPr lang="en-US" dirty="0"/>
            </a:br>
            <a:br>
              <a:rPr lang="en-US" dirty="0"/>
            </a:br>
            <a:r>
              <a:rPr lang="en-US" dirty="0"/>
              <a:t>15 mm aneurysm arising from the right side of the anterior communicating artery</a:t>
            </a:r>
          </a:p>
        </p:txBody>
      </p:sp>
      <p:pic>
        <p:nvPicPr>
          <p:cNvPr id="4" name="Picture 3" descr="A close-up of a ct scan&#10;&#10;Description automatically generated">
            <a:extLst>
              <a:ext uri="{FF2B5EF4-FFF2-40B4-BE49-F238E27FC236}">
                <a16:creationId xmlns:a16="http://schemas.microsoft.com/office/drawing/2014/main" id="{A1C7F7BF-9715-1BDA-E5AF-1A108E7362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1752600"/>
            <a:ext cx="4496140" cy="44961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2199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Box 1"/>
          <p:cNvSpPr txBox="1">
            <a:spLocks noChangeArrowheads="1"/>
          </p:cNvSpPr>
          <p:nvPr/>
        </p:nvSpPr>
        <p:spPr bwMode="auto">
          <a:xfrm>
            <a:off x="5257800" y="1752600"/>
            <a:ext cx="4963680" cy="2308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7200" b="1" dirty="0"/>
              <a:t>Beta hCG:</a:t>
            </a:r>
            <a:endParaRPr lang="en-US" sz="7200" dirty="0"/>
          </a:p>
          <a:p>
            <a:r>
              <a:rPr lang="en-US" sz="7200" dirty="0"/>
              <a:t>Negativ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3997FAB-5600-4C43-9A50-86D2CD3B91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3430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Box 1"/>
          <p:cNvSpPr txBox="1">
            <a:spLocks noChangeArrowheads="1"/>
          </p:cNvSpPr>
          <p:nvPr/>
        </p:nvSpPr>
        <p:spPr bwMode="auto">
          <a:xfrm>
            <a:off x="5257800" y="1752600"/>
            <a:ext cx="4963680" cy="2308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7200" b="1" dirty="0"/>
              <a:t>Blood Type:</a:t>
            </a:r>
            <a:endParaRPr lang="en-US" sz="7200" dirty="0"/>
          </a:p>
          <a:p>
            <a:r>
              <a:rPr lang="en-US" sz="7200" dirty="0"/>
              <a:t>AB +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E92619D-45B5-44A3-9C9E-0BCFE5FA25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44523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609600" y="228600"/>
            <a:ext cx="1998073" cy="1325563"/>
          </a:xfrm>
        </p:spPr>
        <p:txBody>
          <a:bodyPr>
            <a:normAutofit/>
          </a:bodyPr>
          <a:lstStyle/>
          <a:p>
            <a:r>
              <a:rPr lang="en-US" sz="8900" b="1" dirty="0"/>
              <a:t>CBC</a:t>
            </a:r>
            <a:endParaRPr lang="en-US" sz="48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A1A2723-9F6E-4C3C-B70F-3E60A1F523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EABBFF0-28B7-42E1-B37C-20A878F202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57800" y="891381"/>
            <a:ext cx="6705600" cy="54784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BC:	 10.4 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/u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gb:	 	 14.2 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/dL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lt</a:t>
            </a: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		 410  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/u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BC:		 5.1    </a:t>
            </a:r>
            <a:r>
              <a:rPr kumimoji="0" lang="en-US" sz="4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/u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t</a:t>
            </a: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		 41%</a:t>
            </a:r>
          </a:p>
        </p:txBody>
      </p:sp>
    </p:spTree>
    <p:extLst>
      <p:ext uri="{BB962C8B-B14F-4D97-AF65-F5344CB8AC3E}">
        <p14:creationId xmlns:p14="http://schemas.microsoft.com/office/powerpoint/2010/main" val="3881323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04800" y="221817"/>
            <a:ext cx="3164886" cy="1447800"/>
          </a:xfrm>
        </p:spPr>
        <p:txBody>
          <a:bodyPr>
            <a:noAutofit/>
          </a:bodyPr>
          <a:lstStyle/>
          <a:p>
            <a:r>
              <a:rPr lang="en-US" sz="7200" b="1" dirty="0"/>
              <a:t>Chem 7</a:t>
            </a:r>
            <a:endParaRPr lang="en-US" sz="40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5F16492-B6CD-41E0-B047-F197AF4587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35BB33-336B-8CAF-6CF1-F4A65D164A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30875" y="945717"/>
            <a:ext cx="5927725" cy="52629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a:	 		138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:			3.7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l:			110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O₃:		23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lu:		84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UN: 		13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r: 	 		0.9 </a:t>
            </a:r>
            <a:r>
              <a:rPr kumimoji="0" lang="en-US" sz="3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</a:p>
        </p:txBody>
      </p:sp>
    </p:spTree>
    <p:extLst>
      <p:ext uri="{BB962C8B-B14F-4D97-AF65-F5344CB8AC3E}">
        <p14:creationId xmlns:p14="http://schemas.microsoft.com/office/powerpoint/2010/main" val="32549994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04800" y="221817"/>
            <a:ext cx="3733800" cy="1447800"/>
          </a:xfrm>
        </p:spPr>
        <p:txBody>
          <a:bodyPr>
            <a:noAutofit/>
          </a:bodyPr>
          <a:lstStyle/>
          <a:p>
            <a:r>
              <a:rPr lang="en-US" sz="7200" b="1" dirty="0"/>
              <a:t>Chem 10</a:t>
            </a:r>
            <a:endParaRPr lang="en-US" sz="40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5F16492-B6CD-41E0-B047-F197AF4587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035BB33-336B-8CAF-6CF1-F4A65D164A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29400" y="913762"/>
            <a:ext cx="4251325" cy="52014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a:	 	138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:		3.7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l:		110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O₃:	23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q/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lu:		84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UN: 	13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r: 	 	0.9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</a:t>
            </a: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3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:		9.6</a:t>
            </a: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  <a:endParaRPr kumimoji="0" lang="nb-NO" sz="2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3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:		2.1</a:t>
            </a: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  <a:endParaRPr kumimoji="0" lang="nb-NO" sz="2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nb-NO" sz="3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hos:</a:t>
            </a:r>
            <a:r>
              <a:rPr lang="nb-NO" sz="3200" dirty="0">
                <a:latin typeface="Calibri" panose="020F0502020204030204"/>
              </a:rPr>
              <a:t>		</a:t>
            </a:r>
            <a:r>
              <a:rPr kumimoji="0" lang="nb-NO" sz="3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.6</a:t>
            </a: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g/dL</a:t>
            </a:r>
            <a:endParaRPr kumimoji="0" lang="nb-NO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4599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304800" y="152400"/>
            <a:ext cx="2707686" cy="1325563"/>
          </a:xfrm>
        </p:spPr>
        <p:txBody>
          <a:bodyPr>
            <a:normAutofit/>
          </a:bodyPr>
          <a:lstStyle/>
          <a:p>
            <a:r>
              <a:rPr lang="en-US" sz="7000" b="1" dirty="0"/>
              <a:t>Coag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E6BA0AE-C157-4D76-9B89-AA4686460E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38ED33F-9E7E-599D-0A07-80E3F26261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2600" y="2008690"/>
            <a:ext cx="6461125" cy="3323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T:	 	 13  </a:t>
            </a:r>
            <a:r>
              <a:rPr kumimoji="0" lang="en-US" sz="3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onds</a:t>
            </a:r>
            <a:endParaRPr kumimoji="0" lang="en-US" sz="4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defTabSz="914400">
              <a:defRPr/>
            </a:pP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TT:	 28  </a:t>
            </a:r>
            <a:r>
              <a:rPr kumimoji="0" lang="en-US" sz="3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conds</a:t>
            </a:r>
            <a:endParaRPr kumimoji="0" lang="en-US" sz="7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7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R:		 1.0</a:t>
            </a:r>
          </a:p>
        </p:txBody>
      </p:sp>
    </p:spTree>
    <p:extLst>
      <p:ext uri="{BB962C8B-B14F-4D97-AF65-F5344CB8AC3E}">
        <p14:creationId xmlns:p14="http://schemas.microsoft.com/office/powerpoint/2010/main" val="27247446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Box 1"/>
          <p:cNvSpPr txBox="1">
            <a:spLocks noChangeArrowheads="1"/>
          </p:cNvSpPr>
          <p:nvPr/>
        </p:nvSpPr>
        <p:spPr bwMode="auto">
          <a:xfrm>
            <a:off x="5791200" y="1600200"/>
            <a:ext cx="5534025" cy="27699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7200" b="1" dirty="0"/>
              <a:t>Lactate:</a:t>
            </a:r>
          </a:p>
          <a:p>
            <a:endParaRPr lang="en-US" sz="3000" i="1" dirty="0"/>
          </a:p>
          <a:p>
            <a:r>
              <a:rPr lang="en-US" sz="7200" dirty="0">
                <a:solidFill>
                  <a:srgbClr val="FF0000"/>
                </a:solidFill>
              </a:rPr>
              <a:t>4.5 </a:t>
            </a:r>
            <a:r>
              <a:rPr lang="en-US" sz="4000" dirty="0">
                <a:solidFill>
                  <a:srgbClr val="FF0000"/>
                </a:solidFill>
              </a:rPr>
              <a:t>mmol/L</a:t>
            </a:r>
            <a:endParaRPr lang="en-US" sz="7200" dirty="0">
              <a:solidFill>
                <a:srgbClr val="FF0000"/>
              </a:solidFill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D9D0818-84E4-487A-AF56-E7E91340FE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497172">
            <a:off x="833698" y="1423286"/>
            <a:ext cx="3146358" cy="4494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57431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BB2E1-997D-4E24-8CF9-E58C565F5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76313"/>
            <a:ext cx="10515600" cy="1325563"/>
          </a:xfrm>
        </p:spPr>
        <p:txBody>
          <a:bodyPr>
            <a:normAutofit/>
          </a:bodyPr>
          <a:lstStyle/>
          <a:p>
            <a:pPr algn="ctr"/>
            <a:r>
              <a:rPr lang="en-US" sz="5400" b="1" dirty="0"/>
              <a:t>LP Resul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4A55C3-C376-4124-9B15-F3D758680B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199" y="1651607"/>
            <a:ext cx="5181599" cy="4351338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4400" b="1" dirty="0"/>
              <a:t>Tube 1:</a:t>
            </a:r>
          </a:p>
          <a:p>
            <a:pPr marL="0" indent="0">
              <a:buNone/>
            </a:pPr>
            <a:endParaRPr lang="en-US" sz="2000" dirty="0"/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WBC:		18 /uL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RBC:			11,153 /uL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Protein: 		75 mg/dL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Glucose: 		44 mg/dL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Xanthochromia:	Positive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Opening Pressure:	30 mmHg !</a:t>
            </a:r>
          </a:p>
          <a:p>
            <a:endParaRPr lang="en-US" sz="4400" dirty="0"/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36AE0809-0725-47AA-AE14-E6FDEF346B17}"/>
              </a:ext>
            </a:extLst>
          </p:cNvPr>
          <p:cNvSpPr txBox="1">
            <a:spLocks/>
          </p:cNvSpPr>
          <p:nvPr/>
        </p:nvSpPr>
        <p:spPr>
          <a:xfrm>
            <a:off x="6096000" y="1825625"/>
            <a:ext cx="52578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457200" marR="0" lvl="1" indent="0" algn="l" defTabSz="914400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kumimoji="0" 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017BCF4A-5898-4CC7-BD35-ADCF065775BD}"/>
              </a:ext>
            </a:extLst>
          </p:cNvPr>
          <p:cNvSpPr txBox="1">
            <a:spLocks/>
          </p:cNvSpPr>
          <p:nvPr/>
        </p:nvSpPr>
        <p:spPr>
          <a:xfrm>
            <a:off x="6939310" y="1663604"/>
            <a:ext cx="4643090" cy="440795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4400" b="1" dirty="0"/>
              <a:t>Tube 4:</a:t>
            </a:r>
          </a:p>
          <a:p>
            <a:pPr marL="0" indent="0">
              <a:buNone/>
            </a:pPr>
            <a:endParaRPr lang="en-US" sz="2000" dirty="0"/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WBC:		16 /uL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RBC:			10,532 /uL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>
                <a:solidFill>
                  <a:srgbClr val="FF0000"/>
                </a:solidFill>
              </a:rPr>
              <a:t>! Xanthochromia:	Positive !</a:t>
            </a:r>
          </a:p>
          <a:p>
            <a:pPr marL="0" lvl="1" indent="0">
              <a:lnSpc>
                <a:spcPct val="120000"/>
              </a:lnSpc>
              <a:buNone/>
            </a:pPr>
            <a:r>
              <a:rPr lang="en-US" sz="2600" dirty="0"/>
              <a:t>Closing Pressure: 	15 mmHg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ED86DDA2-6334-4BD1-826F-CD9CCD26162D}"/>
              </a:ext>
            </a:extLst>
          </p:cNvPr>
          <p:cNvCxnSpPr/>
          <p:nvPr/>
        </p:nvCxnSpPr>
        <p:spPr>
          <a:xfrm>
            <a:off x="6172200" y="1594991"/>
            <a:ext cx="0" cy="4958209"/>
          </a:xfrm>
          <a:prstGeom prst="line">
            <a:avLst/>
          </a:prstGeom>
          <a:ln w="571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28886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3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1</TotalTime>
  <Words>595</Words>
  <Application>Microsoft Macintosh PowerPoint</Application>
  <PresentationFormat>Widescreen</PresentationFormat>
  <Paragraphs>96</Paragraphs>
  <Slides>14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1_Office Theme</vt:lpstr>
      <vt:lpstr>2_Office Theme</vt:lpstr>
      <vt:lpstr>3_Office Theme</vt:lpstr>
      <vt:lpstr>PowerPoint Presentation</vt:lpstr>
      <vt:lpstr>PowerPoint Presentation</vt:lpstr>
      <vt:lpstr>PowerPoint Presentation</vt:lpstr>
      <vt:lpstr>CBC</vt:lpstr>
      <vt:lpstr>Chem 7</vt:lpstr>
      <vt:lpstr>Chem 10</vt:lpstr>
      <vt:lpstr>Coags</vt:lpstr>
      <vt:lpstr>PowerPoint Presentation</vt:lpstr>
      <vt:lpstr>LP Results</vt:lpstr>
      <vt:lpstr>PowerPoint Presentation</vt:lpstr>
      <vt:lpstr>PowerPoint Presentation</vt:lpstr>
      <vt:lpstr>VBG</vt:lpstr>
      <vt:lpstr>CT Head Without Contrast</vt:lpstr>
      <vt:lpstr>CT Angiography Head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indy</dc:creator>
  <cp:lastModifiedBy>Toohey, Shannon</cp:lastModifiedBy>
  <cp:revision>39</cp:revision>
  <dcterms:created xsi:type="dcterms:W3CDTF">2015-09-14T17:36:20Z</dcterms:created>
  <dcterms:modified xsi:type="dcterms:W3CDTF">2024-06-18T02:44:11Z</dcterms:modified>
</cp:coreProperties>
</file>